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IL A ROBERTSON" initials="GAR" lastIdx="11" clrIdx="0">
    <p:extLst>
      <p:ext uri="{19B8F6BF-5375-455C-9EA6-DF929625EA0E}">
        <p15:presenceInfo xmlns:p15="http://schemas.microsoft.com/office/powerpoint/2012/main" userId="97a3b06b-7fec-4ecd-9741-f2397d70eacd" providerId="Windows Live"/>
      </p:ext>
    </p:extLst>
  </p:cmAuthor>
  <p:cmAuthor id="2" name="Catherine" initials="C" lastIdx="1" clrIdx="1">
    <p:extLst>
      <p:ext uri="{19B8F6BF-5375-455C-9EA6-DF929625EA0E}">
        <p15:presenceInfo xmlns:p15="http://schemas.microsoft.com/office/powerpoint/2012/main" userId="Catherine" providerId="None"/>
      </p:ext>
    </p:extLst>
  </p:cmAuthor>
  <p:cmAuthor id="3" name="GAIL A ROBERTSON" initials="GAR [2]" lastIdx="10" clrIdx="2">
    <p:extLst>
      <p:ext uri="{19B8F6BF-5375-455C-9EA6-DF929625EA0E}">
        <p15:presenceInfo xmlns:p15="http://schemas.microsoft.com/office/powerpoint/2012/main" userId="S::garobert@wisc.edu::97a3b06b-7fec-4ecd-9741-f2397d70eac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DEE3"/>
    <a:srgbClr val="A0F2F4"/>
    <a:srgbClr val="A0F1F4"/>
    <a:srgbClr val="F17286"/>
    <a:srgbClr val="E0697A"/>
    <a:srgbClr val="2EDDE2"/>
    <a:srgbClr val="0080FF"/>
    <a:srgbClr val="000080"/>
    <a:srgbClr val="0087EA"/>
    <a:srgbClr val="6AE2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49" autoAdjust="0"/>
    <p:restoredTop sz="91036" autoAdjust="0"/>
  </p:normalViewPr>
  <p:slideViewPr>
    <p:cSldViewPr snapToGrid="0" snapToObjects="1">
      <p:cViewPr varScale="1">
        <p:scale>
          <a:sx n="71" d="100"/>
          <a:sy n="71" d="100"/>
        </p:scale>
        <p:origin x="2824" y="16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4A77E5-9341-7446-87B9-D14147A0202E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B84732-1DF6-5E40-99F8-E953FE5749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8022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94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28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192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792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225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515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539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207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659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171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026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71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1004846" y="904892"/>
          <a:ext cx="4848307" cy="67208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51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886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44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hERG1a probes</a:t>
                      </a:r>
                      <a:endParaRPr lang="fr-FR" sz="105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SCN5A probes</a:t>
                      </a:r>
                      <a:endParaRPr lang="fr-FR" sz="105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RyR2 probes</a:t>
                      </a:r>
                      <a:endParaRPr lang="fr-FR" sz="105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agactggactgcggg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cgaggtaataggaagt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catttttccacatcaa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gcactaggcttcgggt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agagatctggcagcttt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catccaatttttccttgg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ggaaggtgttctgcg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cttttgggtgctatag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tatagatcccattctc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cttgcggatgatggtg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agatggtcttgccttta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tgctgggatctcgaca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acttacggctctggcc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actgaggacatacaag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aggccccttataaatct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cgagcgttggcgatga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tgtactcgacatacttgg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agtagccaatgagatc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gatgacggcgcagttc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ccagagactcaaaggtg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tgttctgtttgtcttca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gaagccgtcgttgca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gaaggaaagtgaacgcg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gtcgagggagccagaaaa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gagtagccgcacagct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atcacactaaagtccagcc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catccagaaccttgtga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gcagggtcgctgcatcac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ttcagttgtgtatgccat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gcaaacacagagtgag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gtgcaggaagtcgcag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cgtaaggctgagacatt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acagatgagatgctgg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gtgcctgcgcgatct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aggcaaaggaatcgaa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tggttcacaagacgtgtc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gatttccactttgcgct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ggcggaagagtgcaag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tgaaggccatcaaatc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ccatctttccggtagaa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agtaaacgggtccatg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ggtgagcttacagtacg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caccagacataggaag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tgttgagtacgatgca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gttgtccattaattcgg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tcgttcttcacgggca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ctcgaattcacttgtca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tctttcttgcttgta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acatgatgacagcccca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gcaatgatcttgaagg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cttgtcagctggtaatt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cacctcgaaattgagga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tggaagtagtagtaggggtc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atgtgcattttctgcca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accatgtccttctccat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tgacgatgatgctgtcg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aacaaggcgaggattt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gtggttggtgtcatgag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ccgatgatcttgatgagtg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cacggaagattcggaacct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ttcaggcggaaggtct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acacgatgatggctag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tgtgaacatcatggtgtg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ctgtcacttcgtccaggg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agttcttgccaaaga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tgacatcctttccaaag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855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tgccacgtggttgtcca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gttgccaatgaccata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tggtaatatccctgtttg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gtcggggttgaggctgt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tgaatgtctcgaaccagc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gtgttgctgttctgag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tttctcgggagcgcgt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ctgctgagtaggatcat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tcctgggcataatcttt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tggcctcgatgtcgt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taggtagatgtcctcgaa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ctttgttcttctaagc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tgcgcagtgggtgcatgg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agcagaaccttgatgg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acgtggacgtttgcatc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gtggagttgagcaagccg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tctccagcacgaagacata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caaagcctgtgtcat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acgaggtcggagtccga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acttcttgaagccgta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gcaatgaatgtgagca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tgctaatggtgcggtagc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atcgtgacagagctctca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ggacttgtagcttgtgcaaa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ttgagggtgatttgggga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cgaggaggacgttcatgat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gagaggcatcacattc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gcccttgaggtccacaaa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ttcacgatggtgtagt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cttgtgctcactcttg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gcgaagccaagaagggg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gttcaaggactcacactg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cgagacacatctacct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gatctcacggtcactggt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acgttgtcaaagttga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gacaatgtactcgttg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 err="1">
                          <a:solidFill>
                            <a:schemeClr val="tx1"/>
                          </a:solidFill>
                          <a:effectLst/>
                        </a:rPr>
                        <a:t>ctcctttatcttaggtgc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ctgcatacataatgtcca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cttacaaaactgggggag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cctctgtcatgaagatg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cacactgggctcaatca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tggcattgtagtactt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gatctgttcttgaggtg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atatgaagccctggtactt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acgccctctaattgtt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tcatggtcaccatatt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tcactctcaactggtt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cagcttgacaatacactcgc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ggtcttcaatgacagac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ttggtgaagtagtagtggc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tccgaatgagcaatctc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tggagaggatgacaaccacg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atggacctaattctgatggc</a:t>
                      </a:r>
                      <a:endParaRPr lang="fr-FR" sz="105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agagcgtcggggagaaga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gaacctcaatcccataga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atcatgagggcaaagagca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tgtgcaaaggtaccgatt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catgacgaggaagagca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gagaggagcacatcttg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atgccaaagatggagta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gaacagcccttagaaagtc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cccacttgacataagcgaag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aaacttctatggaatcccg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2314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050" b="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aggagatcttggatgggtt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900" dirty="0" err="1">
                          <a:effectLst/>
                        </a:rPr>
                        <a:t>ttctgagtaagtgctgcatc</a:t>
                      </a:r>
                      <a:endParaRPr lang="fr-FR" sz="105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5917" marR="35917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733363" y="244900"/>
            <a:ext cx="2020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le 1</a:t>
            </a:r>
          </a:p>
        </p:txBody>
      </p:sp>
    </p:spTree>
    <p:extLst>
      <p:ext uri="{BB962C8B-B14F-4D97-AF65-F5344CB8AC3E}">
        <p14:creationId xmlns:p14="http://schemas.microsoft.com/office/powerpoint/2010/main" val="7064550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44</TotalTime>
  <Words>153</Words>
  <Application>Microsoft Macintosh PowerPoint</Application>
  <PresentationFormat>Affichage à l'écran (4:3)</PresentationFormat>
  <Paragraphs>14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therine</dc:creator>
  <cp:keywords/>
  <dc:description/>
  <cp:lastModifiedBy>CATHERINE ALEXANDRA EICHEL</cp:lastModifiedBy>
  <cp:revision>410</cp:revision>
  <cp:lastPrinted>2019-10-01T00:24:33Z</cp:lastPrinted>
  <dcterms:created xsi:type="dcterms:W3CDTF">2017-07-07T12:54:23Z</dcterms:created>
  <dcterms:modified xsi:type="dcterms:W3CDTF">2019-10-28T16:08:28Z</dcterms:modified>
  <cp:category/>
</cp:coreProperties>
</file>